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540" y="-105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50298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85607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47340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93931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43211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09963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42200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3105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19279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15276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73827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2C665-BD83-446D-AFE9-69AD95C64EC8}" type="datetimeFigureOut">
              <a:rPr lang="nl-NL" smtClean="0"/>
              <a:t>22-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E0FFD-0C4A-4606-B327-396D394B195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9737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5B0F29E3-89DE-426B-9247-89164B802E3A}"/>
              </a:ext>
            </a:extLst>
          </p:cNvPr>
          <p:cNvGrpSpPr/>
          <p:nvPr/>
        </p:nvGrpSpPr>
        <p:grpSpPr>
          <a:xfrm>
            <a:off x="766915" y="2181322"/>
            <a:ext cx="5087133" cy="3659039"/>
            <a:chOff x="766915" y="2181322"/>
            <a:chExt cx="5087133" cy="365903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CDEFFDC-AB28-469A-99AD-696698D2C3AC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6915" y="2181322"/>
              <a:ext cx="5087133" cy="365903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4DE2BB1-C420-44C7-AE3B-B5EE67BE610C}"/>
                </a:ext>
              </a:extLst>
            </p:cNvPr>
            <p:cNvSpPr txBox="1"/>
            <p:nvPr/>
          </p:nvSpPr>
          <p:spPr>
            <a:xfrm>
              <a:off x="1166884" y="2181322"/>
              <a:ext cx="42990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200" b="1" dirty="0"/>
                <a:t>A</a:t>
              </a:r>
              <a:endParaRPr lang="nl-NL" sz="3200" b="1" dirty="0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CEB18986-A8E6-433C-99B0-52779DC696A8}"/>
                </a:ext>
              </a:extLst>
            </p:cNvPr>
            <p:cNvSpPr/>
            <p:nvPr/>
          </p:nvSpPr>
          <p:spPr>
            <a:xfrm>
              <a:off x="1835624" y="2181322"/>
              <a:ext cx="3159457" cy="3620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D809B4C-AF48-43F9-848C-CB0ACFFEEA9F}"/>
                </a:ext>
              </a:extLst>
            </p:cNvPr>
            <p:cNvSpPr txBox="1"/>
            <p:nvPr/>
          </p:nvSpPr>
          <p:spPr>
            <a:xfrm>
              <a:off x="5326593" y="2468623"/>
              <a:ext cx="52745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TNF (</a:t>
              </a:r>
              <a:r>
                <a:rPr lang="en-US" sz="1100" b="1" dirty="0" err="1"/>
                <a:t>pM</a:t>
              </a:r>
              <a:r>
                <a:rPr lang="en-US" sz="1100" b="1" dirty="0"/>
                <a:t>)</a:t>
              </a:r>
              <a:endParaRPr lang="nl-NL" sz="1100" b="1" dirty="0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5B99DA29-AD86-40BD-92F9-7D93DDF30BDF}"/>
              </a:ext>
            </a:extLst>
          </p:cNvPr>
          <p:cNvSpPr/>
          <p:nvPr/>
        </p:nvSpPr>
        <p:spPr>
          <a:xfrm>
            <a:off x="435520" y="5513655"/>
            <a:ext cx="5630231" cy="634999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noFill/>
            <a:prstDash val="solid"/>
          </a:ln>
          <a:effectLst/>
        </p:spPr>
        <p:txBody>
          <a:bodyPr wrap="square" rtlCol="0" anchor="ctr">
            <a:noAutofit/>
          </a:bodyPr>
          <a:lstStyle/>
          <a:p>
            <a:pPr algn="ctr"/>
            <a:r>
              <a:rPr lang="en-US" sz="1600" b="1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g(fibroblast influx/(fM/min)) </a:t>
            </a:r>
            <a:endParaRPr lang="nl-NL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2F93BC5D-6DEB-4C3F-90D3-F85EDB4E4A9E}"/>
              </a:ext>
            </a:extLst>
          </p:cNvPr>
          <p:cNvGrpSpPr/>
          <p:nvPr/>
        </p:nvGrpSpPr>
        <p:grpSpPr>
          <a:xfrm>
            <a:off x="460854" y="5964867"/>
            <a:ext cx="5630231" cy="3949214"/>
            <a:chOff x="460854" y="5964867"/>
            <a:chExt cx="5630231" cy="3949214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58003AD9-5A4F-4498-B6AA-D49FA5AF9450}"/>
                </a:ext>
              </a:extLst>
            </p:cNvPr>
            <p:cNvGrpSpPr/>
            <p:nvPr/>
          </p:nvGrpSpPr>
          <p:grpSpPr>
            <a:xfrm>
              <a:off x="460854" y="5964867"/>
              <a:ext cx="5630231" cy="3949214"/>
              <a:chOff x="458618" y="5523443"/>
              <a:chExt cx="5630231" cy="3949214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4945BAE0-3595-48DF-AAB5-D0A3DAB91533}"/>
                  </a:ext>
                </a:extLst>
              </p:cNvPr>
              <p:cNvPicPr/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90013" y="5549837"/>
                <a:ext cx="5087133" cy="365904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31A92B0C-42DF-44C3-8F67-F2E155B5CDB1}"/>
                  </a:ext>
                </a:extLst>
              </p:cNvPr>
              <p:cNvSpPr/>
              <p:nvPr/>
            </p:nvSpPr>
            <p:spPr>
              <a:xfrm rot="16200000">
                <a:off x="-1098234" y="7080298"/>
                <a:ext cx="3659040" cy="545330"/>
              </a:xfrm>
              <a:prstGeom prst="rect">
                <a:avLst/>
              </a:prstGeom>
              <a:solidFill>
                <a:sysClr val="window" lastClr="FFFFFF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wrap="square" rtlCol="0" anchor="ctr">
                <a:noAutofit/>
              </a:bodyPr>
              <a:lstStyle/>
              <a:p>
                <a:pPr algn="ctr"/>
                <a:r>
                  <a:rPr lang="en-US" sz="16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CRA influx rate (fM/min)</a:t>
                </a:r>
                <a:endParaRPr lang="nl-NL" sz="2844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45E82A38-4AFF-4631-B01C-3DA0077C570D}"/>
                  </a:ext>
                </a:extLst>
              </p:cNvPr>
              <p:cNvSpPr/>
              <p:nvPr/>
            </p:nvSpPr>
            <p:spPr>
              <a:xfrm>
                <a:off x="458618" y="8837658"/>
                <a:ext cx="5630231" cy="634999"/>
              </a:xfrm>
              <a:prstGeom prst="rect">
                <a:avLst/>
              </a:prstGeom>
              <a:solidFill>
                <a:sysClr val="window" lastClr="FFFFFF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wrap="square" rtlCol="0" anchor="ctr">
                <a:noAutofit/>
              </a:bodyPr>
              <a:lstStyle/>
              <a:p>
                <a:pPr algn="ctr"/>
                <a:r>
                  <a:rPr lang="en-US" sz="1600" b="1" baseline="30000" dirty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r>
                  <a:rPr lang="en-US" sz="16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log(fibroblast influx/(fM/min)) </a:t>
                </a:r>
                <a:endParaRPr lang="nl-NL" sz="16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66B235E-7C1D-486B-8BB2-DF1AFC7E0485}"/>
                  </a:ext>
                </a:extLst>
              </p:cNvPr>
              <p:cNvSpPr txBox="1"/>
              <p:nvPr/>
            </p:nvSpPr>
            <p:spPr>
              <a:xfrm>
                <a:off x="1166882" y="5671331"/>
                <a:ext cx="429904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200" b="1" dirty="0"/>
                  <a:t>B</a:t>
                </a:r>
                <a:endParaRPr lang="nl-NL" sz="3200" b="1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A15DA09E-9FEA-4308-96BA-5E9F9B0FDE58}"/>
                  </a:ext>
                </a:extLst>
              </p:cNvPr>
              <p:cNvSpPr txBox="1"/>
              <p:nvPr/>
            </p:nvSpPr>
            <p:spPr>
              <a:xfrm>
                <a:off x="5364645" y="5803612"/>
                <a:ext cx="527455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TNF (</a:t>
                </a:r>
                <a:r>
                  <a:rPr lang="en-US" sz="1100" b="1" dirty="0" err="1"/>
                  <a:t>pM</a:t>
                </a:r>
                <a:r>
                  <a:rPr lang="en-US" sz="1100" b="1" dirty="0"/>
                  <a:t>)</a:t>
                </a:r>
                <a:endParaRPr lang="nl-NL" sz="1100" b="1" dirty="0"/>
              </a:p>
            </p:txBody>
          </p:sp>
        </p:grp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CF35F14A-B465-4D7E-991B-47E9886796C0}"/>
                </a:ext>
              </a:extLst>
            </p:cNvPr>
            <p:cNvSpPr/>
            <p:nvPr/>
          </p:nvSpPr>
          <p:spPr>
            <a:xfrm>
              <a:off x="1784892" y="6112755"/>
              <a:ext cx="3159457" cy="3620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</p:grpSp>
      <p:sp>
        <p:nvSpPr>
          <p:cNvPr id="5" name="Rectangle 4">
            <a:extLst>
              <a:ext uri="{FF2B5EF4-FFF2-40B4-BE49-F238E27FC236}">
                <a16:creationId xmlns:a16="http://schemas.microsoft.com/office/drawing/2014/main" id="{8F43ADAA-265A-4DFF-AE8D-325DE8EFA704}"/>
              </a:ext>
            </a:extLst>
          </p:cNvPr>
          <p:cNvSpPr/>
          <p:nvPr/>
        </p:nvSpPr>
        <p:spPr>
          <a:xfrm>
            <a:off x="1890215" y="2249415"/>
            <a:ext cx="2501431" cy="456975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noFill/>
            <a:prstDash val="solid"/>
          </a:ln>
          <a:effectLst/>
        </p:spPr>
        <p:txBody>
          <a:bodyPr wrap="square" rtlCol="0" anchor="ctr">
            <a:noAutofit/>
          </a:bodyPr>
          <a:lstStyle/>
          <a:p>
            <a:pPr algn="ctr"/>
            <a:r>
              <a:rPr lang="en-US" sz="1600" b="1" dirty="0">
                <a:solidFill>
                  <a:srgbClr val="1F497D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starting from) acute mode</a:t>
            </a:r>
            <a:endParaRPr lang="nl-NL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E50D515-A94E-4CFA-92AA-0AC9815A4A30}"/>
              </a:ext>
            </a:extLst>
          </p:cNvPr>
          <p:cNvSpPr/>
          <p:nvPr/>
        </p:nvSpPr>
        <p:spPr>
          <a:xfrm rot="16200000">
            <a:off x="-1098233" y="3834774"/>
            <a:ext cx="3659040" cy="54533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noFill/>
            <a:prstDash val="solid"/>
          </a:ln>
          <a:effectLst/>
        </p:spPr>
        <p:txBody>
          <a:bodyPr wrap="square" rtlCol="0" anchor="ctr">
            <a:noAutofit/>
          </a:bodyPr>
          <a:lstStyle/>
          <a:p>
            <a:pPr algn="ctr"/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RA influx rate (fM/min)</a:t>
            </a:r>
            <a:endParaRPr lang="nl-NL" sz="284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9714174-3F3C-4262-B3C6-E1F2579E25E9}"/>
              </a:ext>
            </a:extLst>
          </p:cNvPr>
          <p:cNvSpPr/>
          <p:nvPr/>
        </p:nvSpPr>
        <p:spPr>
          <a:xfrm>
            <a:off x="1890215" y="6224136"/>
            <a:ext cx="2661313" cy="362012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noFill/>
            <a:prstDash val="solid"/>
          </a:ln>
          <a:effectLst/>
        </p:spPr>
        <p:txBody>
          <a:bodyPr wrap="square" rtlCol="0" anchor="ctr">
            <a:noAutofit/>
          </a:bodyPr>
          <a:lstStyle/>
          <a:p>
            <a:pPr algn="ctr"/>
            <a:r>
              <a:rPr lang="en-US" sz="1600" b="1" dirty="0">
                <a:solidFill>
                  <a:srgbClr val="1F497D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starting from) chronic mode</a:t>
            </a:r>
            <a:endParaRPr lang="nl-NL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2468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58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lex stability figure 7</dc:title>
  <dc:creator>"Hans V. Westerhoff</dc:creator>
  <cp:lastModifiedBy>Westerhoff, Hans</cp:lastModifiedBy>
  <cp:revision>8</cp:revision>
  <dcterms:created xsi:type="dcterms:W3CDTF">2020-01-21T22:17:49Z</dcterms:created>
  <dcterms:modified xsi:type="dcterms:W3CDTF">2020-01-22T17:03:11Z</dcterms:modified>
</cp:coreProperties>
</file>